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9906000" cy="6858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General Obesity" id="{95E13395-52DB-4CA5-9BDA-D026BB1D0A90}">
          <p14:sldIdLst>
            <p14:sldId id="256"/>
          </p14:sldIdLst>
        </p14:section>
        <p14:section name="Abdominal obesity" id="{43FF0A64-1248-48B1-9ADC-65E26DD58D90}">
          <p14:sldIdLst>
            <p14:sldId id="257"/>
          </p14:sldIdLst>
        </p14:section>
        <p14:section name="Hypertension" id="{19D61D6E-FA80-4C96-B8DD-AC20EFC3B31D}">
          <p14:sldIdLst>
            <p14:sldId id="258"/>
            <p14:sldId id="259"/>
            <p14:sldId id="260"/>
          </p14:sldIdLst>
        </p14:section>
        <p14:section name="Type2 diabetes mellitus" id="{47737329-0E02-47EC-9C9E-83E8095C648F}">
          <p14:sldIdLst>
            <p14:sldId id="261"/>
          </p14:sldIdLst>
        </p14:section>
        <p14:section name="Hypercholesterolemia" id="{48A3E446-A324-4BC8-A92F-B8BA1C5E0B6B}">
          <p14:sldIdLst>
            <p14:sldId id="262"/>
            <p14:sldId id="263"/>
            <p14:sldId id="264"/>
          </p14:sldIdLst>
        </p14:section>
        <p14:section name="Hypertriglyceridemia" id="{278F0C55-A829-4DB2-89E0-5A1E096040F7}">
          <p14:sldIdLst>
            <p14:sldId id="265"/>
            <p14:sldId id="266"/>
          </p14:sldIdLst>
        </p14:section>
        <p14:section name="Hypo-HDL cholesterolemia" id="{72251638-6FB5-4060-B00C-8B5E93A56430}">
          <p14:sldIdLst>
            <p14:sldId id="267"/>
            <p14:sldId id="268"/>
            <p14:sldId id="269"/>
          </p14:sldIdLst>
        </p14:section>
        <p14:section name="Metabolic syndrome" id="{E3951B08-485D-4BE8-98B0-765712FD74E9}">
          <p14:sldIdLst>
            <p14:sldId id="27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54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8997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4896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789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917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3807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108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922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7147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340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8998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0816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5CD24-A1BD-4574-AA4D-3996CDCF677A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482DA-2F64-4CF4-964C-0875299257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0064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png"/><Relationship Id="rId5" Type="http://schemas.openxmlformats.org/officeDocument/2006/relationships/image" Target="../media/image64.png"/><Relationship Id="rId10" Type="http://schemas.openxmlformats.org/officeDocument/2006/relationships/image" Target="../media/image69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png"/><Relationship Id="rId5" Type="http://schemas.openxmlformats.org/officeDocument/2006/relationships/image" Target="../media/image73.png"/><Relationship Id="rId4" Type="http://schemas.openxmlformats.org/officeDocument/2006/relationships/image" Target="../media/image72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png"/><Relationship Id="rId3" Type="http://schemas.openxmlformats.org/officeDocument/2006/relationships/image" Target="../media/image76.png"/><Relationship Id="rId7" Type="http://schemas.openxmlformats.org/officeDocument/2006/relationships/image" Target="../media/image80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png"/><Relationship Id="rId5" Type="http://schemas.openxmlformats.org/officeDocument/2006/relationships/image" Target="../media/image78.png"/><Relationship Id="rId10" Type="http://schemas.openxmlformats.org/officeDocument/2006/relationships/image" Target="../media/image83.png"/><Relationship Id="rId4" Type="http://schemas.openxmlformats.org/officeDocument/2006/relationships/image" Target="../media/image77.png"/><Relationship Id="rId9" Type="http://schemas.openxmlformats.org/officeDocument/2006/relationships/image" Target="../media/image82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png"/><Relationship Id="rId3" Type="http://schemas.openxmlformats.org/officeDocument/2006/relationships/image" Target="../media/image85.png"/><Relationship Id="rId7" Type="http://schemas.openxmlformats.org/officeDocument/2006/relationships/image" Target="../media/image89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8.png"/><Relationship Id="rId5" Type="http://schemas.openxmlformats.org/officeDocument/2006/relationships/image" Target="../media/image87.png"/><Relationship Id="rId10" Type="http://schemas.openxmlformats.org/officeDocument/2006/relationships/image" Target="../media/image92.png"/><Relationship Id="rId4" Type="http://schemas.openxmlformats.org/officeDocument/2006/relationships/image" Target="../media/image86.png"/><Relationship Id="rId9" Type="http://schemas.openxmlformats.org/officeDocument/2006/relationships/image" Target="../media/image9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png"/><Relationship Id="rId2" Type="http://schemas.openxmlformats.org/officeDocument/2006/relationships/image" Target="../media/image9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1.png"/><Relationship Id="rId3" Type="http://schemas.openxmlformats.org/officeDocument/2006/relationships/image" Target="../media/image96.png"/><Relationship Id="rId7" Type="http://schemas.openxmlformats.org/officeDocument/2006/relationships/image" Target="../media/image100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9.png"/><Relationship Id="rId5" Type="http://schemas.openxmlformats.org/officeDocument/2006/relationships/image" Target="../media/image98.png"/><Relationship Id="rId4" Type="http://schemas.openxmlformats.org/officeDocument/2006/relationships/image" Target="../media/image97.png"/><Relationship Id="rId9" Type="http://schemas.openxmlformats.org/officeDocument/2006/relationships/image" Target="../media/image10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10" Type="http://schemas.openxmlformats.org/officeDocument/2006/relationships/image" Target="../media/image50.png"/><Relationship Id="rId4" Type="http://schemas.openxmlformats.org/officeDocument/2006/relationships/image" Target="../media/image44.png"/><Relationship Id="rId9" Type="http://schemas.openxmlformats.org/officeDocument/2006/relationships/image" Target="../media/image4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3" Type="http://schemas.openxmlformats.org/officeDocument/2006/relationships/image" Target="../media/image52.png"/><Relationship Id="rId7" Type="http://schemas.openxmlformats.org/officeDocument/2006/relationships/image" Target="../media/image56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10" Type="http://schemas.openxmlformats.org/officeDocument/2006/relationships/image" Target="../media/image59.png"/><Relationship Id="rId4" Type="http://schemas.openxmlformats.org/officeDocument/2006/relationships/image" Target="../media/image53.png"/><Relationship Id="rId9" Type="http://schemas.openxmlformats.org/officeDocument/2006/relationships/image" Target="../media/image58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3000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A. General Obesity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grpSp>
        <p:nvGrpSpPr>
          <p:cNvPr id="17" name="그룹 16"/>
          <p:cNvGrpSpPr/>
          <p:nvPr/>
        </p:nvGrpSpPr>
        <p:grpSpPr>
          <a:xfrm>
            <a:off x="266817" y="483946"/>
            <a:ext cx="9372367" cy="6301928"/>
            <a:chOff x="207704" y="459009"/>
            <a:chExt cx="9372367" cy="6301928"/>
          </a:xfrm>
        </p:grpSpPr>
        <p:grpSp>
          <p:nvGrpSpPr>
            <p:cNvPr id="14" name="그룹 13"/>
            <p:cNvGrpSpPr/>
            <p:nvPr/>
          </p:nvGrpSpPr>
          <p:grpSpPr>
            <a:xfrm>
              <a:off x="207704" y="459009"/>
              <a:ext cx="9372367" cy="1980000"/>
              <a:chOff x="207704" y="459009"/>
              <a:chExt cx="9372367" cy="198000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7704" y="459009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79602" y="459009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51500" y="459009"/>
                <a:ext cx="2828571" cy="1980000"/>
              </a:xfrm>
              <a:prstGeom prst="rect">
                <a:avLst/>
              </a:prstGeom>
            </p:spPr>
          </p:pic>
        </p:grpSp>
        <p:grpSp>
          <p:nvGrpSpPr>
            <p:cNvPr id="15" name="그룹 14"/>
            <p:cNvGrpSpPr/>
            <p:nvPr/>
          </p:nvGrpSpPr>
          <p:grpSpPr>
            <a:xfrm>
              <a:off x="3479602" y="2619973"/>
              <a:ext cx="6100468" cy="1980000"/>
              <a:chOff x="3479602" y="2627287"/>
              <a:chExt cx="6100468" cy="1980000"/>
            </a:xfrm>
          </p:grpSpPr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79602" y="2627287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51499" y="2627287"/>
                <a:ext cx="2828571" cy="1980000"/>
              </a:xfrm>
              <a:prstGeom prst="rect">
                <a:avLst/>
              </a:prstGeom>
            </p:spPr>
          </p:pic>
        </p:grpSp>
        <p:grpSp>
          <p:nvGrpSpPr>
            <p:cNvPr id="16" name="그룹 15"/>
            <p:cNvGrpSpPr/>
            <p:nvPr/>
          </p:nvGrpSpPr>
          <p:grpSpPr>
            <a:xfrm>
              <a:off x="207704" y="4780937"/>
              <a:ext cx="9372367" cy="1980000"/>
              <a:chOff x="207704" y="4780937"/>
              <a:chExt cx="9372367" cy="1980000"/>
            </a:xfrm>
          </p:grpSpPr>
          <p:pic>
            <p:nvPicPr>
              <p:cNvPr id="10" name="그림 9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7704" y="4780937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11" name="그림 10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79602" y="4780937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12" name="그림 11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51500" y="4780937"/>
                <a:ext cx="2828571" cy="1980000"/>
              </a:xfrm>
              <a:prstGeom prst="rect">
                <a:avLst/>
              </a:prstGeom>
            </p:spPr>
          </p:pic>
        </p:grpSp>
      </p:grpSp>
      <p:sp>
        <p:nvSpPr>
          <p:cNvPr id="13" name="TextBox 12"/>
          <p:cNvSpPr txBox="1"/>
          <p:nvPr/>
        </p:nvSpPr>
        <p:spPr>
          <a:xfrm>
            <a:off x="1399787" y="289895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675543" y="289895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947441" y="289895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99787" y="2489975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75543" y="2489975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947441" y="2489975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399787" y="4636732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675543" y="4636732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947441" y="4636732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go-L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27" name="그림 2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4120" y="2733811"/>
            <a:ext cx="2831268" cy="19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30584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349288" y="291083"/>
            <a:ext cx="9207425" cy="6375590"/>
            <a:chOff x="323849" y="396685"/>
            <a:chExt cx="9207425" cy="6375590"/>
          </a:xfrm>
        </p:grpSpPr>
        <p:grpSp>
          <p:nvGrpSpPr>
            <p:cNvPr id="12" name="그룹 11"/>
            <p:cNvGrpSpPr/>
            <p:nvPr/>
          </p:nvGrpSpPr>
          <p:grpSpPr>
            <a:xfrm>
              <a:off x="323850" y="2594480"/>
              <a:ext cx="9207424" cy="1980000"/>
              <a:chOff x="323850" y="2654578"/>
              <a:chExt cx="9207424" cy="1980000"/>
            </a:xfrm>
          </p:grpSpPr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850" y="2654578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3276" y="2654578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02703" y="2654578"/>
                <a:ext cx="2828571" cy="1980000"/>
              </a:xfrm>
              <a:prstGeom prst="rect">
                <a:avLst/>
              </a:prstGeom>
            </p:spPr>
          </p:pic>
        </p:grpSp>
        <p:grpSp>
          <p:nvGrpSpPr>
            <p:cNvPr id="11" name="그룹 10"/>
            <p:cNvGrpSpPr/>
            <p:nvPr/>
          </p:nvGrpSpPr>
          <p:grpSpPr>
            <a:xfrm>
              <a:off x="323850" y="396685"/>
              <a:ext cx="9207424" cy="1980000"/>
              <a:chOff x="323850" y="396685"/>
              <a:chExt cx="9207424" cy="198000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850" y="396685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02703" y="396685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3276" y="396685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3" name="그룹 12"/>
            <p:cNvGrpSpPr/>
            <p:nvPr/>
          </p:nvGrpSpPr>
          <p:grpSpPr>
            <a:xfrm>
              <a:off x="323849" y="4792275"/>
              <a:ext cx="9207425" cy="1980000"/>
              <a:chOff x="323849" y="4878000"/>
              <a:chExt cx="9207425" cy="1980000"/>
            </a:xfrm>
          </p:grpSpPr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849" y="4878000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3277" y="4878000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10" name="그림 9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02703" y="4878000"/>
                <a:ext cx="2828571" cy="1980000"/>
              </a:xfrm>
              <a:prstGeom prst="rect">
                <a:avLst/>
              </a:prstGeom>
            </p:spPr>
          </p:pic>
        </p:grpSp>
      </p:grpSp>
      <p:sp>
        <p:nvSpPr>
          <p:cNvPr id="15" name="TextBox 14"/>
          <p:cNvSpPr txBox="1"/>
          <p:nvPr/>
        </p:nvSpPr>
        <p:spPr>
          <a:xfrm>
            <a:off x="1374641" y="1458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53452" y="1458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732263" y="1458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382261" y="23236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63131" y="23236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739883" y="23236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74641" y="452549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53452" y="452549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732263" y="452549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7AD684-0062-E512-D04D-091846B48B41}"/>
              </a:ext>
            </a:extLst>
          </p:cNvPr>
          <p:cNvSpPr txBox="1"/>
          <p:nvPr/>
        </p:nvSpPr>
        <p:spPr>
          <a:xfrm>
            <a:off x="0" y="0"/>
            <a:ext cx="3391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F. Hypertriglyceridemia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05180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431270" y="481730"/>
            <a:ext cx="9043460" cy="4364997"/>
            <a:chOff x="497516" y="1195388"/>
            <a:chExt cx="9043460" cy="4364997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4961" y="1195388"/>
              <a:ext cx="2828571" cy="1980000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12404" y="1195388"/>
              <a:ext cx="2828572" cy="198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516" y="3580385"/>
              <a:ext cx="2828571" cy="198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4960" y="3580385"/>
              <a:ext cx="2828571" cy="198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516" y="1195388"/>
              <a:ext cx="2828572" cy="1980000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1410201" y="29641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10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90041" y="29641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1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692646" y="29641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1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410201" y="271549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1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590041" y="271549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tg-L1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B20FDDA-71BC-FFF2-59CA-BA7DC9F5311F}"/>
              </a:ext>
            </a:extLst>
          </p:cNvPr>
          <p:cNvSpPr txBox="1"/>
          <p:nvPr/>
        </p:nvSpPr>
        <p:spPr>
          <a:xfrm>
            <a:off x="0" y="0"/>
            <a:ext cx="3391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F. Hypertriglyceridemia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00269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그룹 16"/>
          <p:cNvGrpSpPr/>
          <p:nvPr/>
        </p:nvGrpSpPr>
        <p:grpSpPr>
          <a:xfrm>
            <a:off x="400315" y="356866"/>
            <a:ext cx="9105371" cy="6244024"/>
            <a:chOff x="400315" y="135538"/>
            <a:chExt cx="9105371" cy="6244024"/>
          </a:xfrm>
        </p:grpSpPr>
        <p:grpSp>
          <p:nvGrpSpPr>
            <p:cNvPr id="13" name="그룹 12"/>
            <p:cNvGrpSpPr/>
            <p:nvPr/>
          </p:nvGrpSpPr>
          <p:grpSpPr>
            <a:xfrm>
              <a:off x="400316" y="135538"/>
              <a:ext cx="9105370" cy="1980000"/>
              <a:chOff x="511806" y="488950"/>
              <a:chExt cx="9105370" cy="198000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1806" y="488950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50204" y="488950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8604" y="488950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4" name="그룹 13"/>
            <p:cNvGrpSpPr/>
            <p:nvPr/>
          </p:nvGrpSpPr>
          <p:grpSpPr>
            <a:xfrm>
              <a:off x="400315" y="2267550"/>
              <a:ext cx="9105371" cy="1980000"/>
              <a:chOff x="511805" y="2748950"/>
              <a:chExt cx="9105371" cy="198000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1805" y="2748950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50204" y="2748950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8604" y="2748950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5" name="그룹 14"/>
            <p:cNvGrpSpPr/>
            <p:nvPr/>
          </p:nvGrpSpPr>
          <p:grpSpPr>
            <a:xfrm>
              <a:off x="400315" y="4399562"/>
              <a:ext cx="9105371" cy="1980000"/>
              <a:chOff x="511805" y="5095874"/>
              <a:chExt cx="9105371" cy="1980000"/>
            </a:xfrm>
          </p:grpSpPr>
          <p:pic>
            <p:nvPicPr>
              <p:cNvPr id="10" name="그림 9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1805" y="5095874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11" name="그림 10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50203" y="5095874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12" name="그림 11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8604" y="5095874"/>
                <a:ext cx="2828572" cy="1980000"/>
              </a:xfrm>
              <a:prstGeom prst="rect">
                <a:avLst/>
              </a:prstGeom>
            </p:spPr>
          </p:pic>
        </p:grpSp>
      </p:grpSp>
      <p:sp>
        <p:nvSpPr>
          <p:cNvPr id="18" name="TextBox 17"/>
          <p:cNvSpPr txBox="1"/>
          <p:nvPr/>
        </p:nvSpPr>
        <p:spPr>
          <a:xfrm>
            <a:off x="1378451" y="21889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58291" y="21889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736073" y="21889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78451" y="234586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58291" y="234586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736073" y="234586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378451" y="448104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58291" y="448104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736073" y="448104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5DD79BE-AACD-1033-6728-B77221678CAD}"/>
              </a:ext>
            </a:extLst>
          </p:cNvPr>
          <p:cNvSpPr txBox="1"/>
          <p:nvPr/>
        </p:nvSpPr>
        <p:spPr>
          <a:xfrm>
            <a:off x="0" y="0"/>
            <a:ext cx="35387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G. Hypo HDL </a:t>
            </a:r>
            <a:r>
              <a:rPr lang="en-US" altLang="ko-KR" sz="1000" b="1" dirty="0" err="1">
                <a:latin typeface="times" panose="02020603050405020304" pitchFamily="18" charset="0"/>
                <a:cs typeface="times" panose="02020603050405020304" pitchFamily="18" charset="0"/>
              </a:rPr>
              <a:t>cholesterolemia</a:t>
            </a:r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252877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484117" y="286047"/>
            <a:ext cx="8937766" cy="6568543"/>
            <a:chOff x="579715" y="470534"/>
            <a:chExt cx="8937766" cy="6568543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715" y="470534"/>
              <a:ext cx="2828572" cy="1980000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34312" y="470534"/>
              <a:ext cx="2828572" cy="198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8909" y="470534"/>
              <a:ext cx="2828572" cy="198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715" y="2747678"/>
              <a:ext cx="2828571" cy="198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34312" y="2747678"/>
              <a:ext cx="2828572" cy="198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8910" y="2747678"/>
              <a:ext cx="2828571" cy="1980000"/>
            </a:xfrm>
            <a:prstGeom prst="rect">
              <a:avLst/>
            </a:prstGeom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715" y="5059077"/>
              <a:ext cx="2828572" cy="1980000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34312" y="5059077"/>
              <a:ext cx="2828571" cy="1980000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8910" y="5059077"/>
              <a:ext cx="2828571" cy="1980000"/>
            </a:xfrm>
            <a:prstGeom prst="rect">
              <a:avLst/>
            </a:prstGeom>
          </p:spPr>
        </p:pic>
      </p:grpSp>
      <p:sp>
        <p:nvSpPr>
          <p:cNvPr id="15" name="TextBox 14"/>
          <p:cNvSpPr txBox="1"/>
          <p:nvPr/>
        </p:nvSpPr>
        <p:spPr>
          <a:xfrm>
            <a:off x="1511554" y="14960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0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66151" y="14960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620749" y="14960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511554" y="237231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66151" y="237231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620749" y="237231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511553" y="4721193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66151" y="4721193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620749" y="4721193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3F984C-A2D6-ABED-20B2-75288B9E4483}"/>
              </a:ext>
            </a:extLst>
          </p:cNvPr>
          <p:cNvSpPr txBox="1"/>
          <p:nvPr/>
        </p:nvSpPr>
        <p:spPr>
          <a:xfrm>
            <a:off x="0" y="0"/>
            <a:ext cx="35387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G. Hypo HDL </a:t>
            </a:r>
            <a:r>
              <a:rPr lang="en-US" altLang="ko-KR" sz="1000" b="1" dirty="0" err="1">
                <a:latin typeface="times" panose="02020603050405020304" pitchFamily="18" charset="0"/>
                <a:cs typeface="times" panose="02020603050405020304" pitchFamily="18" charset="0"/>
              </a:rPr>
              <a:t>cholesterolemia</a:t>
            </a:r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303219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117" y="360861"/>
            <a:ext cx="2828572" cy="1980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8714" y="360261"/>
            <a:ext cx="2828572" cy="198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511554" y="22441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1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66151" y="22441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dl-L20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6E8EE9C-5E31-CCA6-7B7C-B1E1A30A5F79}"/>
              </a:ext>
            </a:extLst>
          </p:cNvPr>
          <p:cNvSpPr txBox="1"/>
          <p:nvPr/>
        </p:nvSpPr>
        <p:spPr>
          <a:xfrm>
            <a:off x="0" y="0"/>
            <a:ext cx="35387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G. Hypo HDL </a:t>
            </a:r>
            <a:r>
              <a:rPr lang="en-US" altLang="ko-KR" sz="1000" b="1" dirty="0" err="1">
                <a:latin typeface="times" panose="02020603050405020304" pitchFamily="18" charset="0"/>
                <a:cs typeface="times" panose="02020603050405020304" pitchFamily="18" charset="0"/>
              </a:rPr>
              <a:t>cholesterolemia</a:t>
            </a:r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883021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288065" y="390827"/>
            <a:ext cx="9329871" cy="6225980"/>
            <a:chOff x="288065" y="158848"/>
            <a:chExt cx="9329871" cy="6225980"/>
          </a:xfrm>
        </p:grpSpPr>
        <p:grpSp>
          <p:nvGrpSpPr>
            <p:cNvPr id="10" name="그룹 9"/>
            <p:cNvGrpSpPr/>
            <p:nvPr/>
          </p:nvGrpSpPr>
          <p:grpSpPr>
            <a:xfrm>
              <a:off x="288065" y="158848"/>
              <a:ext cx="9329871" cy="1980000"/>
              <a:chOff x="411029" y="691779"/>
              <a:chExt cx="9329871" cy="198000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1029" y="691779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61679" y="691779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12328" y="691779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1" name="그룹 10"/>
            <p:cNvGrpSpPr/>
            <p:nvPr/>
          </p:nvGrpSpPr>
          <p:grpSpPr>
            <a:xfrm>
              <a:off x="288065" y="2281838"/>
              <a:ext cx="9329871" cy="1980000"/>
              <a:chOff x="411029" y="3032571"/>
              <a:chExt cx="9329871" cy="198000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1029" y="3032571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12329" y="3032571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61678" y="3032571"/>
                <a:ext cx="2828571" cy="1980000"/>
              </a:xfrm>
              <a:prstGeom prst="rect">
                <a:avLst/>
              </a:prstGeom>
            </p:spPr>
          </p:pic>
        </p:grpSp>
        <p:grpSp>
          <p:nvGrpSpPr>
            <p:cNvPr id="12" name="그룹 11"/>
            <p:cNvGrpSpPr/>
            <p:nvPr/>
          </p:nvGrpSpPr>
          <p:grpSpPr>
            <a:xfrm>
              <a:off x="288066" y="4404828"/>
              <a:ext cx="6079219" cy="1980000"/>
              <a:chOff x="411030" y="5252084"/>
              <a:chExt cx="6079219" cy="1980000"/>
            </a:xfrm>
          </p:grpSpPr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61677" y="5252084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1030" y="5252084"/>
                <a:ext cx="2828571" cy="1980000"/>
              </a:xfrm>
              <a:prstGeom prst="rect">
                <a:avLst/>
              </a:prstGeom>
            </p:spPr>
          </p:pic>
        </p:grpSp>
      </p:grpSp>
      <p:sp>
        <p:nvSpPr>
          <p:cNvPr id="15" name="TextBox 14"/>
          <p:cNvSpPr txBox="1"/>
          <p:nvPr/>
        </p:nvSpPr>
        <p:spPr>
          <a:xfrm>
            <a:off x="1378451" y="24383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58291" y="24383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736073" y="24383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378451" y="237080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58291" y="237080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L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736073" y="237080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L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78451" y="4505987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-L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58291" y="4505987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mets-L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0626B9C-33C5-A600-D3CC-FB6C6256E323}"/>
              </a:ext>
            </a:extLst>
          </p:cNvPr>
          <p:cNvSpPr txBox="1"/>
          <p:nvPr/>
        </p:nvSpPr>
        <p:spPr>
          <a:xfrm>
            <a:off x="0" y="0"/>
            <a:ext cx="35387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</a:t>
            </a:r>
            <a:r>
              <a:rPr lang="en-US" altLang="ko-KR" sz="1000" b="1">
                <a:latin typeface="times" panose="02020603050405020304" pitchFamily="18" charset="0"/>
                <a:cs typeface="times" panose="02020603050405020304" pitchFamily="18" charset="0"/>
              </a:rPr>
              <a:t>Figure S9H</a:t>
            </a:r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. Metabolic Syndrome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3342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290256" y="381601"/>
            <a:ext cx="6549036" cy="4448880"/>
            <a:chOff x="1566999" y="1007744"/>
            <a:chExt cx="6549036" cy="4448880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6999" y="1007744"/>
              <a:ext cx="2828572" cy="1980000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7463" y="1007744"/>
              <a:ext cx="2828572" cy="198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6999" y="3476624"/>
              <a:ext cx="2828572" cy="198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7463" y="3476624"/>
              <a:ext cx="2828572" cy="198000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1423227" y="192047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ab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147867" y="192047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ab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23227" y="2641470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ab-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47867" y="2641470"/>
            <a:ext cx="562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ab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9E320C-0525-3F84-34F1-01F15A93FF74}"/>
              </a:ext>
            </a:extLst>
          </p:cNvPr>
          <p:cNvSpPr txBox="1"/>
          <p:nvPr/>
        </p:nvSpPr>
        <p:spPr>
          <a:xfrm>
            <a:off x="0" y="0"/>
            <a:ext cx="30008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B. Abdominal Obesity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6534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그룹 38"/>
          <p:cNvGrpSpPr/>
          <p:nvPr/>
        </p:nvGrpSpPr>
        <p:grpSpPr>
          <a:xfrm>
            <a:off x="228528" y="327914"/>
            <a:ext cx="9448945" cy="6301928"/>
            <a:chOff x="245870" y="278036"/>
            <a:chExt cx="9448945" cy="6301928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870" y="278036"/>
              <a:ext cx="2828572" cy="1980000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6057" y="278036"/>
              <a:ext cx="2828572" cy="198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66244" y="278036"/>
              <a:ext cx="2828571" cy="198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870" y="2439000"/>
              <a:ext cx="2828572" cy="198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6057" y="2439000"/>
              <a:ext cx="2828572" cy="198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66243" y="2439000"/>
              <a:ext cx="2828572" cy="1980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870" y="4599964"/>
              <a:ext cx="2828572" cy="198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6057" y="4599964"/>
              <a:ext cx="2828572" cy="1980000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66243" y="4599964"/>
              <a:ext cx="2828572" cy="1980000"/>
            </a:xfrm>
            <a:prstGeom prst="rect">
              <a:avLst/>
            </a:prstGeom>
          </p:spPr>
        </p:pic>
      </p:grpSp>
      <p:sp>
        <p:nvSpPr>
          <p:cNvPr id="40" name="TextBox 39"/>
          <p:cNvSpPr txBox="1"/>
          <p:nvPr/>
        </p:nvSpPr>
        <p:spPr>
          <a:xfrm>
            <a:off x="1255966" y="14047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566153" y="14089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7876339" y="14695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255966" y="230144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566153" y="230186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876339" y="230791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255966" y="446845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566153" y="446887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876339" y="447493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EADAD8-2772-5EAA-AB73-53ED3B248DA5}"/>
              </a:ext>
            </a:extLst>
          </p:cNvPr>
          <p:cNvSpPr txBox="1"/>
          <p:nvPr/>
        </p:nvSpPr>
        <p:spPr>
          <a:xfrm>
            <a:off x="0" y="0"/>
            <a:ext cx="3000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C. Hypertension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68667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그룹 12"/>
          <p:cNvGrpSpPr/>
          <p:nvPr/>
        </p:nvGrpSpPr>
        <p:grpSpPr>
          <a:xfrm>
            <a:off x="359903" y="322276"/>
            <a:ext cx="9186194" cy="6557045"/>
            <a:chOff x="436697" y="300955"/>
            <a:chExt cx="9186194" cy="6557045"/>
          </a:xfrm>
        </p:grpSpPr>
        <p:grpSp>
          <p:nvGrpSpPr>
            <p:cNvPr id="10" name="그룹 9"/>
            <p:cNvGrpSpPr/>
            <p:nvPr/>
          </p:nvGrpSpPr>
          <p:grpSpPr>
            <a:xfrm>
              <a:off x="436698" y="300955"/>
              <a:ext cx="9186193" cy="1980000"/>
              <a:chOff x="436698" y="300955"/>
              <a:chExt cx="9186193" cy="198000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6698" y="300955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5508" y="300955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94319" y="300955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1" name="그룹 10"/>
            <p:cNvGrpSpPr/>
            <p:nvPr/>
          </p:nvGrpSpPr>
          <p:grpSpPr>
            <a:xfrm>
              <a:off x="436698" y="2589477"/>
              <a:ext cx="9186193" cy="1980000"/>
              <a:chOff x="436698" y="2650463"/>
              <a:chExt cx="9186193" cy="198000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6698" y="2650463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94319" y="2650463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2" name="그룹 11"/>
            <p:cNvGrpSpPr/>
            <p:nvPr/>
          </p:nvGrpSpPr>
          <p:grpSpPr>
            <a:xfrm>
              <a:off x="436697" y="4878000"/>
              <a:ext cx="9186194" cy="1980000"/>
              <a:chOff x="436697" y="4878000"/>
              <a:chExt cx="9186194" cy="1980000"/>
            </a:xfrm>
          </p:grpSpPr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6697" y="4878000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5509" y="4878000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94320" y="4878000"/>
                <a:ext cx="2828571" cy="1980000"/>
              </a:xfrm>
              <a:prstGeom prst="rect">
                <a:avLst/>
              </a:prstGeom>
            </p:spPr>
          </p:pic>
        </p:grpSp>
      </p:grpSp>
      <p:sp>
        <p:nvSpPr>
          <p:cNvPr id="14" name="TextBox 13"/>
          <p:cNvSpPr txBox="1"/>
          <p:nvPr/>
        </p:nvSpPr>
        <p:spPr>
          <a:xfrm>
            <a:off x="1387341" y="13062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0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66152" y="13062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744963" y="13062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387341" y="24379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568211" y="24379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744963" y="24379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387341" y="472361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566152" y="472361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744963" y="472361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6655" y="2610798"/>
            <a:ext cx="2828572" cy="198000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954493EA-3906-3E61-0A35-9BD02B3D18C3}"/>
              </a:ext>
            </a:extLst>
          </p:cNvPr>
          <p:cNvSpPr txBox="1"/>
          <p:nvPr/>
        </p:nvSpPr>
        <p:spPr>
          <a:xfrm>
            <a:off x="0" y="0"/>
            <a:ext cx="3000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C. Hypertension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9464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87341" y="14725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htn-L1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04" y="338902"/>
            <a:ext cx="2828571" cy="198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17EB8E7-0F93-D9E3-59D0-00EF7B12E38C}"/>
              </a:ext>
            </a:extLst>
          </p:cNvPr>
          <p:cNvSpPr txBox="1"/>
          <p:nvPr/>
        </p:nvSpPr>
        <p:spPr>
          <a:xfrm>
            <a:off x="0" y="0"/>
            <a:ext cx="3000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C. Hypertension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96904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그룹 14"/>
          <p:cNvGrpSpPr/>
          <p:nvPr/>
        </p:nvGrpSpPr>
        <p:grpSpPr>
          <a:xfrm>
            <a:off x="309830" y="325930"/>
            <a:ext cx="9286340" cy="6339148"/>
            <a:chOff x="309830" y="34636"/>
            <a:chExt cx="9286340" cy="6339148"/>
          </a:xfrm>
        </p:grpSpPr>
        <p:grpSp>
          <p:nvGrpSpPr>
            <p:cNvPr id="11" name="그룹 10"/>
            <p:cNvGrpSpPr/>
            <p:nvPr/>
          </p:nvGrpSpPr>
          <p:grpSpPr>
            <a:xfrm>
              <a:off x="309830" y="34636"/>
              <a:ext cx="9286340" cy="1980000"/>
              <a:chOff x="427809" y="498348"/>
              <a:chExt cx="9286340" cy="198000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7809" y="498348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56693" y="498348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85577" y="498348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2" name="그룹 11"/>
            <p:cNvGrpSpPr/>
            <p:nvPr/>
          </p:nvGrpSpPr>
          <p:grpSpPr>
            <a:xfrm>
              <a:off x="309831" y="2214210"/>
              <a:ext cx="9286339" cy="1980000"/>
              <a:chOff x="427810" y="2901142"/>
              <a:chExt cx="9286339" cy="198000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7810" y="2901142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56693" y="2901142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85577" y="2901142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3" name="그룹 12"/>
            <p:cNvGrpSpPr/>
            <p:nvPr/>
          </p:nvGrpSpPr>
          <p:grpSpPr>
            <a:xfrm>
              <a:off x="309831" y="4393784"/>
              <a:ext cx="9286339" cy="1980000"/>
              <a:chOff x="427810" y="5307076"/>
              <a:chExt cx="9286339" cy="1980000"/>
            </a:xfrm>
          </p:grpSpPr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7810" y="5307076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56692" y="5307076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10" name="그림 9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85578" y="5307076"/>
                <a:ext cx="2828571" cy="1980000"/>
              </a:xfrm>
              <a:prstGeom prst="rect">
                <a:avLst/>
              </a:prstGeom>
            </p:spPr>
          </p:pic>
        </p:grpSp>
      </p:grpSp>
      <p:sp>
        <p:nvSpPr>
          <p:cNvPr id="16" name="TextBox 15"/>
          <p:cNvSpPr txBox="1"/>
          <p:nvPr/>
        </p:nvSpPr>
        <p:spPr>
          <a:xfrm>
            <a:off x="1349241" y="12439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28052" y="12439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706863" y="12439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356861" y="23021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37731" y="23021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714483" y="23021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349241" y="450402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28052" y="450402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706863" y="4504024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dm-L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D2579E8-2B80-DFAA-1245-54BBFBB743F5}"/>
              </a:ext>
            </a:extLst>
          </p:cNvPr>
          <p:cNvSpPr txBox="1"/>
          <p:nvPr/>
        </p:nvSpPr>
        <p:spPr>
          <a:xfrm>
            <a:off x="0" y="0"/>
            <a:ext cx="3000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D. Type 2 diabetes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28911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그룹 12"/>
          <p:cNvGrpSpPr/>
          <p:nvPr/>
        </p:nvGrpSpPr>
        <p:grpSpPr>
          <a:xfrm>
            <a:off x="405859" y="301198"/>
            <a:ext cx="9094282" cy="6355360"/>
            <a:chOff x="434653" y="346586"/>
            <a:chExt cx="9094282" cy="6355360"/>
          </a:xfrm>
        </p:grpSpPr>
        <p:grpSp>
          <p:nvGrpSpPr>
            <p:cNvPr id="10" name="그룹 9"/>
            <p:cNvGrpSpPr/>
            <p:nvPr/>
          </p:nvGrpSpPr>
          <p:grpSpPr>
            <a:xfrm>
              <a:off x="434653" y="346586"/>
              <a:ext cx="9094282" cy="1980000"/>
              <a:chOff x="434653" y="498986"/>
              <a:chExt cx="9094282" cy="198000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4653" y="498986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7508" y="498986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00363" y="498986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2" name="그룹 11"/>
            <p:cNvGrpSpPr/>
            <p:nvPr/>
          </p:nvGrpSpPr>
          <p:grpSpPr>
            <a:xfrm>
              <a:off x="434653" y="4721946"/>
              <a:ext cx="9094282" cy="1980000"/>
              <a:chOff x="434653" y="4721946"/>
              <a:chExt cx="9094282" cy="1980000"/>
            </a:xfrm>
          </p:grpSpPr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4653" y="4721946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7508" y="4721946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00364" y="4721946"/>
                <a:ext cx="2828571" cy="1980000"/>
              </a:xfrm>
              <a:prstGeom prst="rect">
                <a:avLst/>
              </a:prstGeom>
            </p:spPr>
          </p:pic>
        </p:grpSp>
        <p:grpSp>
          <p:nvGrpSpPr>
            <p:cNvPr id="11" name="그룹 10"/>
            <p:cNvGrpSpPr/>
            <p:nvPr/>
          </p:nvGrpSpPr>
          <p:grpSpPr>
            <a:xfrm>
              <a:off x="434653" y="2534266"/>
              <a:ext cx="5961427" cy="1980000"/>
              <a:chOff x="434653" y="2544726"/>
              <a:chExt cx="5961427" cy="198000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7508" y="2544726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4653" y="2544726"/>
                <a:ext cx="2828572" cy="1980000"/>
              </a:xfrm>
              <a:prstGeom prst="rect">
                <a:avLst/>
              </a:prstGeom>
            </p:spPr>
          </p:pic>
        </p:grpSp>
      </p:grpSp>
      <p:sp>
        <p:nvSpPr>
          <p:cNvPr id="14" name="TextBox 13"/>
          <p:cNvSpPr txBox="1"/>
          <p:nvPr/>
        </p:nvSpPr>
        <p:spPr>
          <a:xfrm>
            <a:off x="1349241" y="1077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28052" y="1077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706863" y="107766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356861" y="22855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537731" y="22855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714483" y="2285540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349241" y="448739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528052" y="448739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706863" y="4487398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1569" y="2488878"/>
            <a:ext cx="2828572" cy="19800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9280FDC5-EF19-2139-91C6-0139709DC4AF}"/>
              </a:ext>
            </a:extLst>
          </p:cNvPr>
          <p:cNvSpPr txBox="1"/>
          <p:nvPr/>
        </p:nvSpPr>
        <p:spPr>
          <a:xfrm>
            <a:off x="0" y="0"/>
            <a:ext cx="3391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E. Hypercholesterolemia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28059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그룹 14"/>
          <p:cNvGrpSpPr/>
          <p:nvPr/>
        </p:nvGrpSpPr>
        <p:grpSpPr>
          <a:xfrm>
            <a:off x="517549" y="395045"/>
            <a:ext cx="8870903" cy="6167667"/>
            <a:chOff x="517549" y="449942"/>
            <a:chExt cx="8870903" cy="6167667"/>
          </a:xfrm>
        </p:grpSpPr>
        <p:grpSp>
          <p:nvGrpSpPr>
            <p:cNvPr id="11" name="그룹 10"/>
            <p:cNvGrpSpPr/>
            <p:nvPr/>
          </p:nvGrpSpPr>
          <p:grpSpPr>
            <a:xfrm>
              <a:off x="517549" y="449942"/>
              <a:ext cx="8870903" cy="1980000"/>
              <a:chOff x="492171" y="378297"/>
              <a:chExt cx="8870903" cy="198000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2171" y="378297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3337" y="378297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4503" y="378297"/>
                <a:ext cx="2828571" cy="1980000"/>
              </a:xfrm>
              <a:prstGeom prst="rect">
                <a:avLst/>
              </a:prstGeom>
            </p:spPr>
          </p:pic>
        </p:grpSp>
        <p:grpSp>
          <p:nvGrpSpPr>
            <p:cNvPr id="12" name="그룹 11"/>
            <p:cNvGrpSpPr/>
            <p:nvPr/>
          </p:nvGrpSpPr>
          <p:grpSpPr>
            <a:xfrm>
              <a:off x="517549" y="2543776"/>
              <a:ext cx="8870903" cy="1980000"/>
              <a:chOff x="492171" y="2750633"/>
              <a:chExt cx="8870903" cy="198000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2171" y="2750633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3337" y="2750633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4502" y="2750633"/>
                <a:ext cx="2828572" cy="1980000"/>
              </a:xfrm>
              <a:prstGeom prst="rect">
                <a:avLst/>
              </a:prstGeom>
            </p:spPr>
          </p:pic>
        </p:grpSp>
        <p:grpSp>
          <p:nvGrpSpPr>
            <p:cNvPr id="13" name="그룹 12"/>
            <p:cNvGrpSpPr/>
            <p:nvPr/>
          </p:nvGrpSpPr>
          <p:grpSpPr>
            <a:xfrm>
              <a:off x="517550" y="4637609"/>
              <a:ext cx="8870902" cy="1980000"/>
              <a:chOff x="492172" y="5118414"/>
              <a:chExt cx="8870902" cy="1980000"/>
            </a:xfrm>
          </p:grpSpPr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2172" y="5118414"/>
                <a:ext cx="2828571" cy="1980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3337" y="5118414"/>
                <a:ext cx="2828572" cy="1980000"/>
              </a:xfrm>
              <a:prstGeom prst="rect">
                <a:avLst/>
              </a:prstGeom>
            </p:spPr>
          </p:pic>
          <p:pic>
            <p:nvPicPr>
              <p:cNvPr id="10" name="그림 9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4503" y="5118414"/>
                <a:ext cx="2828571" cy="1980000"/>
              </a:xfrm>
              <a:prstGeom prst="rect">
                <a:avLst/>
              </a:prstGeom>
            </p:spPr>
          </p:pic>
        </p:grpSp>
      </p:grpSp>
      <p:sp>
        <p:nvSpPr>
          <p:cNvPr id="16" name="TextBox 15"/>
          <p:cNvSpPr txBox="1"/>
          <p:nvPr/>
        </p:nvSpPr>
        <p:spPr>
          <a:xfrm>
            <a:off x="1544987" y="21573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0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66153" y="21573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1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587318" y="21573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2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44987" y="235184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3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66153" y="235184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4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587318" y="2351841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5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540072" y="445483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6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66153" y="445483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7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587318" y="4454832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8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0DE7A6-104B-28F2-1FD7-0C735EF951C0}"/>
              </a:ext>
            </a:extLst>
          </p:cNvPr>
          <p:cNvSpPr txBox="1"/>
          <p:nvPr/>
        </p:nvSpPr>
        <p:spPr>
          <a:xfrm>
            <a:off x="0" y="0"/>
            <a:ext cx="3391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E. Hypercholesterolemia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82989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549" y="395045"/>
            <a:ext cx="2828572" cy="198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44987" y="215735"/>
            <a:ext cx="773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[ch-L19]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19889D-0529-1643-EE66-83BC57DE3DD5}"/>
              </a:ext>
            </a:extLst>
          </p:cNvPr>
          <p:cNvSpPr txBox="1"/>
          <p:nvPr/>
        </p:nvSpPr>
        <p:spPr>
          <a:xfrm>
            <a:off x="0" y="0"/>
            <a:ext cx="3391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S9E. Hypercholesterolemia  Loci </a:t>
            </a:r>
            <a:endParaRPr lang="ko-KR" altLang="en-US" sz="10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0214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7bd5990b-edd3-4961-a58c-391ff7dcc3ab}" enabled="1" method="Privileged" siteId="{17dc7d94-0f4b-4944-a177-9babce316029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</TotalTime>
  <Words>407</Words>
  <Application>Microsoft Office PowerPoint</Application>
  <PresentationFormat>A4 Paper (210x297 mm)</PresentationFormat>
  <Paragraphs>117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times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ra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최자은</dc:creator>
  <cp:lastModifiedBy>MDPI-124</cp:lastModifiedBy>
  <cp:revision>15</cp:revision>
  <dcterms:created xsi:type="dcterms:W3CDTF">2022-10-03T03:46:49Z</dcterms:created>
  <dcterms:modified xsi:type="dcterms:W3CDTF">2022-10-06T13:43:10Z</dcterms:modified>
</cp:coreProperties>
</file>